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8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9</a:t>
            </a:r>
          </a:p>
        </p:txBody>
      </p:sp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286531" y="982701"/>
            <a:ext cx="4366900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US" sz="1400" b="1" baseline="30000">
                <a:latin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 line treatment-TMB interaction models from Figure 5.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The (A) TTNT and (B) OS interaction models are shown for for propensity adjusted analyses in Figure 5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08C7FA-82EC-2044-91F9-0227F815F58E}"/>
              </a:ext>
            </a:extLst>
          </p:cNvPr>
          <p:cNvSpPr txBox="1"/>
          <p:nvPr/>
        </p:nvSpPr>
        <p:spPr>
          <a:xfrm>
            <a:off x="5581038" y="490654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9C30823-36CD-0A4A-A9F2-C547B7D5334B}"/>
              </a:ext>
            </a:extLst>
          </p:cNvPr>
          <p:cNvSpPr txBox="1"/>
          <p:nvPr/>
        </p:nvSpPr>
        <p:spPr>
          <a:xfrm>
            <a:off x="5581038" y="1892747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2567B997-C101-1F4B-BEE1-36982ED6EDF8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576301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2.35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25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4.41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50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94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2.39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8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4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21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 0.0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03DF3EB0-238A-7B4B-AA05-FC7CA4EF4B5D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1955335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80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6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3.75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11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8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9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57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6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16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3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3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2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82575904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0</Words>
  <Application>Microsoft Macintosh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9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12</cp:revision>
  <dcterms:created xsi:type="dcterms:W3CDTF">2022-06-12T16:24:02Z</dcterms:created>
  <dcterms:modified xsi:type="dcterms:W3CDTF">2022-08-13T14:35:10Z</dcterms:modified>
</cp:coreProperties>
</file>